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9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BAX</a:t>
            </a:r>
            <a:r>
              <a:rPr lang="en-GB" sz="1600" dirty="0" smtClean="0"/>
              <a:t> gene. A) Wild (Template</a:t>
            </a:r>
            <a:r>
              <a:rPr lang="en-US" sz="1600" dirty="0" smtClean="0"/>
              <a:t> 4s0o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s0o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16046" y="714356"/>
            <a:ext cx="3198698" cy="22860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133351"/>
            <a:ext cx="3143272" cy="2867021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571876"/>
            <a:ext cx="3239257" cy="22860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094535"/>
            <a:ext cx="3143272" cy="289019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3</cp:revision>
  <dcterms:created xsi:type="dcterms:W3CDTF">2018-05-10T07:33:24Z</dcterms:created>
  <dcterms:modified xsi:type="dcterms:W3CDTF">2018-05-29T06:51:41Z</dcterms:modified>
</cp:coreProperties>
</file>